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53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317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08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14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59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361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554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362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386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980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233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576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EA651-A758-4F70-96A4-C8884B2E8A4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761C6-8D43-4556-B056-120265E5E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60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439" y="652379"/>
            <a:ext cx="8629917" cy="501048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14400" y="5662863"/>
            <a:ext cx="111590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33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or quinoline, phenyl benzamides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4-benzamidopyridine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quinazoline, carbazole, nicotinamide and miscellaneous compounds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gainst sensitive strain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235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4905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9:14Z</dcterms:created>
  <dcterms:modified xsi:type="dcterms:W3CDTF">2020-08-04T16:38:43Z</dcterms:modified>
</cp:coreProperties>
</file>